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60" r:id="rId2"/>
  </p:sldIdLst>
  <p:sldSz cx="6119813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0F0"/>
    <a:srgbClr val="F1F1F1"/>
    <a:srgbClr val="F2F2F2"/>
    <a:srgbClr val="F1EEEE"/>
    <a:srgbClr val="F4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533A5B-5876-4039-9E18-56F2FD7CD16A}" v="2" dt="2023-07-06T07:16:18.53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439"/>
    <p:restoredTop sz="81891"/>
  </p:normalViewPr>
  <p:slideViewPr>
    <p:cSldViewPr snapToGrid="0" snapToObjects="1">
      <p:cViewPr varScale="1">
        <p:scale>
          <a:sx n="121" d="100"/>
          <a:sy n="121" d="100"/>
        </p:scale>
        <p:origin x="20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qing Min" userId="51edddc9-9564-491f-a389-71c09ec32ef9" providerId="ADAL" clId="{06533A5B-5876-4039-9E18-56F2FD7CD16A}"/>
    <pc:docChg chg="modSld">
      <pc:chgData name="Danqing Min" userId="51edddc9-9564-491f-a389-71c09ec32ef9" providerId="ADAL" clId="{06533A5B-5876-4039-9E18-56F2FD7CD16A}" dt="2023-07-06T07:16:28.358" v="3" actId="1076"/>
      <pc:docMkLst>
        <pc:docMk/>
      </pc:docMkLst>
      <pc:sldChg chg="addSp modSp mod">
        <pc:chgData name="Danqing Min" userId="51edddc9-9564-491f-a389-71c09ec32ef9" providerId="ADAL" clId="{06533A5B-5876-4039-9E18-56F2FD7CD16A}" dt="2023-07-06T07:16:28.358" v="3" actId="1076"/>
        <pc:sldMkLst>
          <pc:docMk/>
          <pc:sldMk cId="1604255843" sldId="260"/>
        </pc:sldMkLst>
        <pc:spChg chg="mod">
          <ac:chgData name="Danqing Min" userId="51edddc9-9564-491f-a389-71c09ec32ef9" providerId="ADAL" clId="{06533A5B-5876-4039-9E18-56F2FD7CD16A}" dt="2023-07-06T07:16:15.016" v="0" actId="164"/>
          <ac:spMkLst>
            <pc:docMk/>
            <pc:sldMk cId="1604255843" sldId="260"/>
            <ac:spMk id="57" creationId="{E292222D-89C3-D443-987B-57D5952868D9}"/>
          </ac:spMkLst>
        </pc:spChg>
        <pc:spChg chg="mod">
          <ac:chgData name="Danqing Min" userId="51edddc9-9564-491f-a389-71c09ec32ef9" providerId="ADAL" clId="{06533A5B-5876-4039-9E18-56F2FD7CD16A}" dt="2023-07-06T07:16:15.016" v="0" actId="164"/>
          <ac:spMkLst>
            <pc:docMk/>
            <pc:sldMk cId="1604255843" sldId="260"/>
            <ac:spMk id="58" creationId="{55FC6318-1490-884C-9603-FB317CAE01AF}"/>
          </ac:spMkLst>
        </pc:spChg>
        <pc:spChg chg="mod">
          <ac:chgData name="Danqing Min" userId="51edddc9-9564-491f-a389-71c09ec32ef9" providerId="ADAL" clId="{06533A5B-5876-4039-9E18-56F2FD7CD16A}" dt="2023-07-06T07:16:15.016" v="0" actId="164"/>
          <ac:spMkLst>
            <pc:docMk/>
            <pc:sldMk cId="1604255843" sldId="260"/>
            <ac:spMk id="62" creationId="{5E8BBAB3-0F65-DA43-9577-D9C177F868C9}"/>
          </ac:spMkLst>
        </pc:spChg>
        <pc:spChg chg="mod">
          <ac:chgData name="Danqing Min" userId="51edddc9-9564-491f-a389-71c09ec32ef9" providerId="ADAL" clId="{06533A5B-5876-4039-9E18-56F2FD7CD16A}" dt="2023-07-06T07:16:15.016" v="0" actId="164"/>
          <ac:spMkLst>
            <pc:docMk/>
            <pc:sldMk cId="1604255843" sldId="260"/>
            <ac:spMk id="63" creationId="{7306772C-6676-A94D-B317-2FABB8CFA92B}"/>
          </ac:spMkLst>
        </pc:spChg>
        <pc:spChg chg="mod">
          <ac:chgData name="Danqing Min" userId="51edddc9-9564-491f-a389-71c09ec32ef9" providerId="ADAL" clId="{06533A5B-5876-4039-9E18-56F2FD7CD16A}" dt="2023-07-06T07:16:15.016" v="0" actId="164"/>
          <ac:spMkLst>
            <pc:docMk/>
            <pc:sldMk cId="1604255843" sldId="260"/>
            <ac:spMk id="66" creationId="{8366B9C3-3319-F54F-8A04-7E8F021067B8}"/>
          </ac:spMkLst>
        </pc:spChg>
        <pc:spChg chg="mod">
          <ac:chgData name="Danqing Min" userId="51edddc9-9564-491f-a389-71c09ec32ef9" providerId="ADAL" clId="{06533A5B-5876-4039-9E18-56F2FD7CD16A}" dt="2023-07-06T07:16:15.016" v="0" actId="164"/>
          <ac:spMkLst>
            <pc:docMk/>
            <pc:sldMk cId="1604255843" sldId="260"/>
            <ac:spMk id="71" creationId="{46EEFAAB-55A5-FB48-8796-B74DB4B4CEBC}"/>
          </ac:spMkLst>
        </pc:spChg>
        <pc:spChg chg="mod">
          <ac:chgData name="Danqing Min" userId="51edddc9-9564-491f-a389-71c09ec32ef9" providerId="ADAL" clId="{06533A5B-5876-4039-9E18-56F2FD7CD16A}" dt="2023-07-06T07:16:15.016" v="0" actId="164"/>
          <ac:spMkLst>
            <pc:docMk/>
            <pc:sldMk cId="1604255843" sldId="260"/>
            <ac:spMk id="72" creationId="{02726D19-391C-EE47-B869-13A3CDA3F08A}"/>
          </ac:spMkLst>
        </pc:spChg>
        <pc:grpChg chg="add mod">
          <ac:chgData name="Danqing Min" userId="51edddc9-9564-491f-a389-71c09ec32ef9" providerId="ADAL" clId="{06533A5B-5876-4039-9E18-56F2FD7CD16A}" dt="2023-07-06T07:16:28.358" v="3" actId="1076"/>
          <ac:grpSpMkLst>
            <pc:docMk/>
            <pc:sldMk cId="1604255843" sldId="260"/>
            <ac:grpSpMk id="2" creationId="{BB1E8CAC-884A-D206-608D-32FD98F5C74D}"/>
          </ac:grpSpMkLst>
        </pc:grpChg>
        <pc:grpChg chg="mod">
          <ac:chgData name="Danqing Min" userId="51edddc9-9564-491f-a389-71c09ec32ef9" providerId="ADAL" clId="{06533A5B-5876-4039-9E18-56F2FD7CD16A}" dt="2023-07-06T07:16:15.016" v="0" actId="164"/>
          <ac:grpSpMkLst>
            <pc:docMk/>
            <pc:sldMk cId="1604255843" sldId="260"/>
            <ac:grpSpMk id="8" creationId="{9D7F50B4-EBEE-7542-BAE9-6675757D4FB7}"/>
          </ac:grpSpMkLst>
        </pc:grpChg>
        <pc:grpChg chg="mod">
          <ac:chgData name="Danqing Min" userId="51edddc9-9564-491f-a389-71c09ec32ef9" providerId="ADAL" clId="{06533A5B-5876-4039-9E18-56F2FD7CD16A}" dt="2023-07-06T07:16:15.016" v="0" actId="164"/>
          <ac:grpSpMkLst>
            <pc:docMk/>
            <pc:sldMk cId="1604255843" sldId="260"/>
            <ac:grpSpMk id="67" creationId="{4A4801A3-5FC4-F74F-98C4-FDA6538F85C9}"/>
          </ac:grpSpMkLst>
        </pc:grpChg>
        <pc:grpChg chg="mod">
          <ac:chgData name="Danqing Min" userId="51edddc9-9564-491f-a389-71c09ec32ef9" providerId="ADAL" clId="{06533A5B-5876-4039-9E18-56F2FD7CD16A}" dt="2023-07-06T07:16:15.016" v="0" actId="164"/>
          <ac:grpSpMkLst>
            <pc:docMk/>
            <pc:sldMk cId="1604255843" sldId="260"/>
            <ac:grpSpMk id="118" creationId="{6673C4B5-69BF-BB43-80D7-127C1E640719}"/>
          </ac:grpSpMkLst>
        </pc:grpChg>
        <pc:picChg chg="mod">
          <ac:chgData name="Danqing Min" userId="51edddc9-9564-491f-a389-71c09ec32ef9" providerId="ADAL" clId="{06533A5B-5876-4039-9E18-56F2FD7CD16A}" dt="2023-07-06T07:16:15.016" v="0" actId="164"/>
          <ac:picMkLst>
            <pc:docMk/>
            <pc:sldMk cId="1604255843" sldId="260"/>
            <ac:picMk id="59" creationId="{5E02A0C2-4802-E241-A248-F7096803C001}"/>
          </ac:picMkLst>
        </pc:picChg>
        <pc:picChg chg="mod">
          <ac:chgData name="Danqing Min" userId="51edddc9-9564-491f-a389-71c09ec32ef9" providerId="ADAL" clId="{06533A5B-5876-4039-9E18-56F2FD7CD16A}" dt="2023-07-06T07:16:15.016" v="0" actId="164"/>
          <ac:picMkLst>
            <pc:docMk/>
            <pc:sldMk cId="1604255843" sldId="260"/>
            <ac:picMk id="60" creationId="{39A3E040-5798-9643-87EE-FD8845403C5F}"/>
          </ac:picMkLst>
        </pc:picChg>
        <pc:picChg chg="mod">
          <ac:chgData name="Danqing Min" userId="51edddc9-9564-491f-a389-71c09ec32ef9" providerId="ADAL" clId="{06533A5B-5876-4039-9E18-56F2FD7CD16A}" dt="2023-07-06T07:16:15.016" v="0" actId="164"/>
          <ac:picMkLst>
            <pc:docMk/>
            <pc:sldMk cId="1604255843" sldId="260"/>
            <ac:picMk id="61" creationId="{016EA59D-F453-B34E-AABE-A71783B4251D}"/>
          </ac:picMkLst>
        </pc:picChg>
        <pc:picChg chg="mod">
          <ac:chgData name="Danqing Min" userId="51edddc9-9564-491f-a389-71c09ec32ef9" providerId="ADAL" clId="{06533A5B-5876-4039-9E18-56F2FD7CD16A}" dt="2023-07-06T07:16:15.016" v="0" actId="164"/>
          <ac:picMkLst>
            <pc:docMk/>
            <pc:sldMk cId="1604255843" sldId="260"/>
            <ac:picMk id="64" creationId="{F43DE25D-E39E-A149-8647-D4CF99ECBCE5}"/>
          </ac:picMkLst>
        </pc:picChg>
        <pc:cxnChg chg="mod">
          <ac:chgData name="Danqing Min" userId="51edddc9-9564-491f-a389-71c09ec32ef9" providerId="ADAL" clId="{06533A5B-5876-4039-9E18-56F2FD7CD16A}" dt="2023-07-06T07:16:15.016" v="0" actId="164"/>
          <ac:cxnSpMkLst>
            <pc:docMk/>
            <pc:sldMk cId="1604255843" sldId="260"/>
            <ac:cxnSpMk id="15" creationId="{1ED607D7-F8C6-7045-8C3E-9FF32E7F8EE7}"/>
          </ac:cxnSpMkLst>
        </pc:cxnChg>
        <pc:cxnChg chg="mod">
          <ac:chgData name="Danqing Min" userId="51edddc9-9564-491f-a389-71c09ec32ef9" providerId="ADAL" clId="{06533A5B-5876-4039-9E18-56F2FD7CD16A}" dt="2023-07-06T07:16:15.016" v="0" actId="164"/>
          <ac:cxnSpMkLst>
            <pc:docMk/>
            <pc:sldMk cId="1604255843" sldId="260"/>
            <ac:cxnSpMk id="68" creationId="{6748AAA7-881F-DB49-BC71-7FD6BA9D8548}"/>
          </ac:cxnSpMkLst>
        </pc:cxnChg>
        <pc:cxnChg chg="mod">
          <ac:chgData name="Danqing Min" userId="51edddc9-9564-491f-a389-71c09ec32ef9" providerId="ADAL" clId="{06533A5B-5876-4039-9E18-56F2FD7CD16A}" dt="2023-07-06T07:16:15.016" v="0" actId="164"/>
          <ac:cxnSpMkLst>
            <pc:docMk/>
            <pc:sldMk cId="1604255843" sldId="260"/>
            <ac:cxnSpMk id="69" creationId="{27F33F64-06FD-A74B-B1EE-FEB48F345969}"/>
          </ac:cxnSpMkLst>
        </pc:cxnChg>
        <pc:cxnChg chg="mod">
          <ac:chgData name="Danqing Min" userId="51edddc9-9564-491f-a389-71c09ec32ef9" providerId="ADAL" clId="{06533A5B-5876-4039-9E18-56F2FD7CD16A}" dt="2023-07-06T07:16:15.016" v="0" actId="164"/>
          <ac:cxnSpMkLst>
            <pc:docMk/>
            <pc:sldMk cId="1604255843" sldId="260"/>
            <ac:cxnSpMk id="70" creationId="{DAC1E73E-FE1B-FE4E-B83F-C2E09FFEEB38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441812-51F3-0D47-A777-664C9DC080E5}" type="datetimeFigureOut">
              <a:rPr lang="en-AU" smtClean="0"/>
              <a:t>29/8/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1288" y="1143000"/>
            <a:ext cx="4035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8852D0-A1AC-3148-9B50-C791561184C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54836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1288" y="1143000"/>
            <a:ext cx="4035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8852D0-A1AC-3148-9B50-C791561184C8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547091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765909"/>
            <a:ext cx="5201841" cy="162931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458058"/>
            <a:ext cx="4589860" cy="1129904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45905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1114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249164"/>
            <a:ext cx="1319585" cy="396604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49164"/>
            <a:ext cx="3882256" cy="396604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1205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4230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166739"/>
            <a:ext cx="5278339" cy="1946729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3131884"/>
            <a:ext cx="5278339" cy="102373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7806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245820"/>
            <a:ext cx="2600921" cy="296938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245820"/>
            <a:ext cx="2600921" cy="296938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00680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9165"/>
            <a:ext cx="5278339" cy="90457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147238"/>
            <a:ext cx="2588967" cy="56224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1709482"/>
            <a:ext cx="2588967" cy="251439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147238"/>
            <a:ext cx="2601718" cy="56224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709482"/>
            <a:ext cx="2601718" cy="251439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6132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3641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528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1997"/>
            <a:ext cx="1973799" cy="109198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673827"/>
            <a:ext cx="3098155" cy="3325798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03985"/>
            <a:ext cx="1973799" cy="26010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2350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1997"/>
            <a:ext cx="1973799" cy="109198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673827"/>
            <a:ext cx="3098155" cy="3325798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03985"/>
            <a:ext cx="1973799" cy="26010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64379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249165"/>
            <a:ext cx="5278339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245820"/>
            <a:ext cx="5278339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4337621"/>
            <a:ext cx="137695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FDD3A-0644-4449-ACE8-7C022004F650}" type="datetimeFigureOut">
              <a:rPr lang="en-AU" smtClean="0"/>
              <a:t>29/8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4337621"/>
            <a:ext cx="2065437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4337621"/>
            <a:ext cx="137695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DA36ED-4551-D142-AC35-2ABB539246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25243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13" Type="http://schemas.openxmlformats.org/officeDocument/2006/relationships/image" Target="../media/image9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8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11" Type="http://schemas.microsoft.com/office/2007/relationships/hdphoto" Target="../media/hdphoto2.wdp"/><Relationship Id="rId5" Type="http://schemas.openxmlformats.org/officeDocument/2006/relationships/image" Target="../media/image3.png"/><Relationship Id="rId10" Type="http://schemas.microsoft.com/office/2007/relationships/hdphoto" Target="../media/hdphoto1.wdp"/><Relationship Id="rId4" Type="http://schemas.openxmlformats.org/officeDocument/2006/relationships/image" Target="../media/image2.sv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B1E8CAC-884A-D206-608D-32FD98F5C74D}"/>
              </a:ext>
            </a:extLst>
          </p:cNvPr>
          <p:cNvGrpSpPr>
            <a:grpSpLocks noChangeAspect="1"/>
          </p:cNvGrpSpPr>
          <p:nvPr/>
        </p:nvGrpSpPr>
        <p:grpSpPr>
          <a:xfrm>
            <a:off x="114044" y="420090"/>
            <a:ext cx="5745420" cy="3839770"/>
            <a:chOff x="1030838" y="1690688"/>
            <a:chExt cx="4787850" cy="3199808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9D7F50B4-EBEE-7542-BAE9-6675757D4FB7}"/>
                </a:ext>
              </a:extLst>
            </p:cNvPr>
            <p:cNvGrpSpPr/>
            <p:nvPr/>
          </p:nvGrpSpPr>
          <p:grpSpPr>
            <a:xfrm>
              <a:off x="1030838" y="1690688"/>
              <a:ext cx="4787850" cy="1633778"/>
              <a:chOff x="0" y="1"/>
              <a:chExt cx="4788017" cy="1633782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C5970ACB-982A-134C-B182-8F74337357CA}"/>
                  </a:ext>
                </a:extLst>
              </p:cNvPr>
              <p:cNvGrpSpPr/>
              <p:nvPr/>
            </p:nvGrpSpPr>
            <p:grpSpPr>
              <a:xfrm>
                <a:off x="54709" y="49142"/>
                <a:ext cx="4733308" cy="1318536"/>
                <a:chOff x="54711" y="49141"/>
                <a:chExt cx="2051599" cy="571507"/>
              </a:xfrm>
            </p:grpSpPr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895FDDD0-3E69-DC42-83CA-C3D254739F1E}"/>
                    </a:ext>
                  </a:extLst>
                </p:cNvPr>
                <p:cNvGrpSpPr/>
                <p:nvPr/>
              </p:nvGrpSpPr>
              <p:grpSpPr>
                <a:xfrm>
                  <a:off x="258894" y="49141"/>
                  <a:ext cx="1847416" cy="337192"/>
                  <a:chOff x="258894" y="49141"/>
                  <a:chExt cx="1847416" cy="337192"/>
                </a:xfrm>
              </p:grpSpPr>
              <p:grpSp>
                <p:nvGrpSpPr>
                  <p:cNvPr id="100" name="Group 99">
                    <a:extLst>
                      <a:ext uri="{FF2B5EF4-FFF2-40B4-BE49-F238E27FC236}">
                        <a16:creationId xmlns:a16="http://schemas.microsoft.com/office/drawing/2014/main" id="{816E1E9D-331C-2F48-951D-AE926A82ABD7}"/>
                      </a:ext>
                    </a:extLst>
                  </p:cNvPr>
                  <p:cNvGrpSpPr/>
                  <p:nvPr/>
                </p:nvGrpSpPr>
                <p:grpSpPr>
                  <a:xfrm>
                    <a:off x="258894" y="49141"/>
                    <a:ext cx="1847416" cy="337192"/>
                    <a:chOff x="258894" y="49141"/>
                    <a:chExt cx="1847416" cy="337192"/>
                  </a:xfrm>
                </p:grpSpPr>
                <p:grpSp>
                  <p:nvGrpSpPr>
                    <p:cNvPr id="102" name="Group 101">
                      <a:extLst>
                        <a:ext uri="{FF2B5EF4-FFF2-40B4-BE49-F238E27FC236}">
                          <a16:creationId xmlns:a16="http://schemas.microsoft.com/office/drawing/2014/main" id="{1B9CA4D1-2215-CE4A-8EE6-ED94A8B9F56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8894" y="49141"/>
                      <a:ext cx="1780093" cy="337192"/>
                      <a:chOff x="258894" y="49141"/>
                      <a:chExt cx="1780093" cy="337192"/>
                    </a:xfrm>
                  </p:grpSpPr>
                  <p:grpSp>
                    <p:nvGrpSpPr>
                      <p:cNvPr id="105" name="Group 104">
                        <a:extLst>
                          <a:ext uri="{FF2B5EF4-FFF2-40B4-BE49-F238E27FC236}">
                            <a16:creationId xmlns:a16="http://schemas.microsoft.com/office/drawing/2014/main" id="{A047231B-6FC0-4D46-A291-3548C60F6D2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8902" y="49141"/>
                        <a:ext cx="1769175" cy="88935"/>
                        <a:chOff x="258873" y="49141"/>
                        <a:chExt cx="8485114" cy="88935"/>
                      </a:xfrm>
                    </p:grpSpPr>
                    <p:sp>
                      <p:nvSpPr>
                        <p:cNvPr id="115" name="TextBox 38">
                          <a:extLst>
                            <a:ext uri="{FF2B5EF4-FFF2-40B4-BE49-F238E27FC236}">
                              <a16:creationId xmlns:a16="http://schemas.microsoft.com/office/drawing/2014/main" id="{C4658CA5-934A-C848-9937-101AA1882A1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58873" y="49141"/>
                          <a:ext cx="8485114" cy="8893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dirty="0">
                              <a:solidFill>
                                <a:srgbClr val="C85700"/>
                              </a:solidFill>
                              <a:latin typeface="Arial" panose="020B0604020202020204" pitchFamily="34" charset="0"/>
                              <a:ea typeface="DengXian" panose="02010600030101010101" pitchFamily="2" charset="-122"/>
                              <a:cs typeface="Arial" panose="020B0604020202020204" pitchFamily="34" charset="0"/>
                            </a:rPr>
                            <a:t>High-Fat Diet</a:t>
                          </a:r>
                          <a:endParaRPr lang="en-AU" sz="1200" dirty="0">
                            <a:latin typeface="Arial" panose="020B0604020202020204" pitchFamily="34" charset="0"/>
                            <a:ea typeface="DengXian" panose="02010600030101010101" pitchFamily="2" charset="-122"/>
                            <a:cs typeface="Arial" panose="020B0604020202020204" pitchFamily="34" charset="0"/>
                          </a:endParaRPr>
                        </a:p>
                      </p:txBody>
                    </p:sp>
                    <p:cxnSp>
                      <p:nvCxnSpPr>
                        <p:cNvPr id="116" name="Straight Arrow Connector 115">
                          <a:extLst>
                            <a:ext uri="{FF2B5EF4-FFF2-40B4-BE49-F238E27FC236}">
                              <a16:creationId xmlns:a16="http://schemas.microsoft.com/office/drawing/2014/main" id="{6933A78F-BE20-7743-A50F-DDF3E91A61E6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5373721" y="99500"/>
                          <a:ext cx="3370264" cy="0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rgbClr val="C85700"/>
                          </a:solidFill>
                          <a:tailEnd type="oval" w="sm" len="sm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17" name="Straight Arrow Connector 116">
                          <a:extLst>
                            <a:ext uri="{FF2B5EF4-FFF2-40B4-BE49-F238E27FC236}">
                              <a16:creationId xmlns:a16="http://schemas.microsoft.com/office/drawing/2014/main" id="{98471F50-0BE9-3545-AE19-07F0B8B26CD7}"/>
                            </a:ext>
                          </a:extLst>
                        </p:cNvPr>
                        <p:cNvCxnSpPr>
                          <a:cxnSpLocks/>
                          <a:endCxn id="115" idx="1"/>
                        </p:cNvCxnSpPr>
                        <p:nvPr/>
                      </p:nvCxnSpPr>
                      <p:spPr>
                        <a:xfrm flipH="1" flipV="1">
                          <a:off x="258873" y="93608"/>
                          <a:ext cx="3370266" cy="4790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rgbClr val="C85700"/>
                          </a:solidFill>
                          <a:tailEnd type="oval" w="sm" len="sm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106" name="Straight Connector 105">
                        <a:extLst>
                          <a:ext uri="{FF2B5EF4-FFF2-40B4-BE49-F238E27FC236}">
                            <a16:creationId xmlns:a16="http://schemas.microsoft.com/office/drawing/2014/main" id="{D49A11AC-D6BC-7043-AE30-39D6D73B0458}"/>
                          </a:ext>
                        </a:extLst>
                      </p:cNvPr>
                      <p:cNvCxnSpPr>
                        <a:cxnSpLocks/>
                        <a:endCxn id="112" idx="1"/>
                      </p:cNvCxnSpPr>
                      <p:nvPr/>
                    </p:nvCxnSpPr>
                    <p:spPr bwMode="auto">
                      <a:xfrm>
                        <a:off x="258997" y="229417"/>
                        <a:ext cx="678788" cy="984"/>
                      </a:xfrm>
                      <a:prstGeom prst="line">
                        <a:avLst/>
                      </a:prstGeom>
                      <a:ln w="152400">
                        <a:solidFill>
                          <a:srgbClr val="FF9300"/>
                        </a:solidFill>
                        <a:headEnd type="none" w="med" len="med"/>
                        <a:tailEnd type="non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7" name="Straight Connector 106">
                        <a:extLst>
                          <a:ext uri="{FF2B5EF4-FFF2-40B4-BE49-F238E27FC236}">
                            <a16:creationId xmlns:a16="http://schemas.microsoft.com/office/drawing/2014/main" id="{99451669-CF14-BF43-BF9B-BEE220E0D82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 flipV="1">
                        <a:off x="944600" y="229417"/>
                        <a:ext cx="842634" cy="984"/>
                      </a:xfrm>
                      <a:prstGeom prst="line">
                        <a:avLst/>
                      </a:prstGeom>
                      <a:ln w="152400">
                        <a:solidFill>
                          <a:srgbClr val="FF9300"/>
                        </a:solidFill>
                        <a:headEnd type="none" w="med" len="med"/>
                        <a:tailEnd type="non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8" name="Straight Connector 107">
                        <a:extLst>
                          <a:ext uri="{FF2B5EF4-FFF2-40B4-BE49-F238E27FC236}">
                            <a16:creationId xmlns:a16="http://schemas.microsoft.com/office/drawing/2014/main" id="{A3849874-FF15-9A46-8765-1FE69B52731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1795350" y="229417"/>
                        <a:ext cx="234687" cy="0"/>
                      </a:xfrm>
                      <a:prstGeom prst="line">
                        <a:avLst/>
                      </a:prstGeom>
                      <a:ln w="152400">
                        <a:solidFill>
                          <a:srgbClr val="945200"/>
                        </a:solidFill>
                        <a:headEnd type="none" w="med" len="med"/>
                        <a:tailEnd type="non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9" name="Rectangle 108">
                        <a:extLst>
                          <a:ext uri="{FF2B5EF4-FFF2-40B4-BE49-F238E27FC236}">
                            <a16:creationId xmlns:a16="http://schemas.microsoft.com/office/drawing/2014/main" id="{4E7073B1-2F66-794F-8BE9-3E8A66764A3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8894" y="119536"/>
                        <a:ext cx="678788" cy="83377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ctr"/>
                        <a:r>
                          <a:rPr lang="en-GB" sz="9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DengXian" panose="02010600030101010101" pitchFamily="2" charset="-122"/>
                            <a:cs typeface="Arial" panose="020B0604020202020204" pitchFamily="34" charset="0"/>
                          </a:rPr>
                          <a:t>8 weeks</a:t>
                        </a:r>
                        <a:endParaRPr lang="en-AU" sz="1600" dirty="0"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0" name="Rectangle 109">
                        <a:extLst>
                          <a:ext uri="{FF2B5EF4-FFF2-40B4-BE49-F238E27FC236}">
                            <a16:creationId xmlns:a16="http://schemas.microsoft.com/office/drawing/2014/main" id="{8E48758E-3137-9C4B-9DDA-EF19B858FA0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44600" y="118194"/>
                        <a:ext cx="842634" cy="83377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ctr"/>
                        <a:r>
                          <a:rPr lang="en-GB" sz="9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DengXian" panose="02010600030101010101" pitchFamily="2" charset="-122"/>
                            <a:cs typeface="Arial" panose="020B0604020202020204" pitchFamily="34" charset="0"/>
                          </a:rPr>
                          <a:t>10 weeks</a:t>
                        </a:r>
                        <a:endParaRPr lang="en-AU" sz="1600" dirty="0"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1" name="Rectangle 110">
                        <a:extLst>
                          <a:ext uri="{FF2B5EF4-FFF2-40B4-BE49-F238E27FC236}">
                            <a16:creationId xmlns:a16="http://schemas.microsoft.com/office/drawing/2014/main" id="{39C521AC-08BD-6045-8C76-C51DD21999A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772667" y="115396"/>
                        <a:ext cx="266320" cy="83377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ctr"/>
                        <a:r>
                          <a:rPr lang="en-GB" sz="9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DengXian" panose="02010600030101010101" pitchFamily="2" charset="-122"/>
                            <a:cs typeface="Arial" panose="020B0604020202020204" pitchFamily="34" charset="0"/>
                          </a:rPr>
                          <a:t>10 days</a:t>
                        </a:r>
                        <a:endParaRPr lang="en-AU" sz="1600" dirty="0"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pic>
                    <p:nvPicPr>
                      <p:cNvPr id="112" name="Graphic 35" descr="Needle with solid fill">
                        <a:extLst>
                          <a:ext uri="{FF2B5EF4-FFF2-40B4-BE49-F238E27FC236}">
                            <a16:creationId xmlns:a16="http://schemas.microsoft.com/office/drawing/2014/main" id="{5411DE71-3496-A544-9028-218167925B1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  <a:ext uri="{96DAC541-7B7A-43D3-8B79-37D633B846F1}">
                            <asvg:svgBlip xmlns:asvg="http://schemas.microsoft.com/office/drawing/2016/SVG/main" r:embed="rId4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914743" y="190980"/>
                        <a:ext cx="78843" cy="78843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13" name="Graphic 36" descr="Adhesive Bandage with solid fill">
                        <a:extLst>
                          <a:ext uri="{FF2B5EF4-FFF2-40B4-BE49-F238E27FC236}">
                            <a16:creationId xmlns:a16="http://schemas.microsoft.com/office/drawing/2014/main" id="{00A8E136-9677-3E4E-9CF3-0885B16645AA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  <a:ext uri="{96DAC541-7B7A-43D3-8B79-37D633B846F1}">
                            <asvg:svgBlip xmlns:asvg="http://schemas.microsoft.com/office/drawing/2016/SVG/main" r:embed="rId6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751393" y="194537"/>
                        <a:ext cx="73941" cy="7394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14" name="Rectangle 113">
                        <a:extLst>
                          <a:ext uri="{FF2B5EF4-FFF2-40B4-BE49-F238E27FC236}">
                            <a16:creationId xmlns:a16="http://schemas.microsoft.com/office/drawing/2014/main" id="{E1427D97-F624-A147-9749-96AB08A88E1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94383" y="252930"/>
                        <a:ext cx="319563" cy="133403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ctr"/>
                        <a:r>
                          <a:rPr lang="en-GB" sz="900" dirty="0">
                            <a:solidFill>
                              <a:srgbClr val="C85700"/>
                            </a:solidFill>
                            <a:latin typeface="Arial" panose="020B0604020202020204" pitchFamily="34" charset="0"/>
                            <a:ea typeface="DengXian" panose="02010600030101010101" pitchFamily="2" charset="-122"/>
                            <a:cs typeface="Arial" panose="020B0604020202020204" pitchFamily="34" charset="0"/>
                          </a:rPr>
                          <a:t>STZ</a:t>
                        </a:r>
                        <a:r>
                          <a:rPr lang="en-GB" sz="9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DengXian" panose="02010600030101010101" pitchFamily="2" charset="-122"/>
                            <a:cs typeface="Arial" panose="020B0604020202020204" pitchFamily="34" charset="0"/>
                          </a:rPr>
                          <a:t> </a:t>
                        </a:r>
                        <a:endParaRPr lang="en-AU" sz="1600" dirty="0"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endParaRPr>
                      </a:p>
                      <a:p>
                        <a:pPr algn="ctr"/>
                        <a:r>
                          <a:rPr lang="en-GB" sz="9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DengXian" panose="02010600030101010101" pitchFamily="2" charset="-122"/>
                            <a:cs typeface="Arial" panose="020B0604020202020204" pitchFamily="34" charset="0"/>
                          </a:rPr>
                          <a:t>injections</a:t>
                        </a:r>
                        <a:endParaRPr lang="en-AU" sz="1600" dirty="0"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03" name="Rectangle 102">
                      <a:extLst>
                        <a:ext uri="{FF2B5EF4-FFF2-40B4-BE49-F238E27FC236}">
                          <a16:creationId xmlns:a16="http://schemas.microsoft.com/office/drawing/2014/main" id="{2FA01BF6-5FE3-5F44-A6D4-5C110089B31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18997" y="243473"/>
                      <a:ext cx="152479" cy="100052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GB" sz="12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Ⓒ</a:t>
                      </a:r>
                      <a:endParaRPr lang="en-AU" sz="1200"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4" name="Rectangle 103">
                      <a:extLst>
                        <a:ext uri="{FF2B5EF4-FFF2-40B4-BE49-F238E27FC236}">
                          <a16:creationId xmlns:a16="http://schemas.microsoft.com/office/drawing/2014/main" id="{531080C4-789D-6E4C-A6F2-44AA70CA307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953831" y="246276"/>
                      <a:ext cx="152479" cy="100052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GB" sz="12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Ⓓ</a:t>
                      </a:r>
                      <a:endParaRPr lang="en-AU" sz="1200" dirty="0"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101" name="Graphic 24" descr="Camera with solid fill">
                    <a:extLst>
                      <a:ext uri="{FF2B5EF4-FFF2-40B4-BE49-F238E27FC236}">
                        <a16:creationId xmlns:a16="http://schemas.microsoft.com/office/drawing/2014/main" id="{8785AF42-BFAA-ED4A-9751-74C62FD5B6D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/>
                      </a:ext>
                      <a:ext uri="{96DAC541-7B7A-43D3-8B79-37D633B846F1}">
                        <asvg:svgBlip xmlns:asvg="http://schemas.microsoft.com/office/drawing/2016/SVG/main" r:embed="rId8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70086" y="260769"/>
                    <a:ext cx="85553" cy="85553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90" name="Group 89">
                  <a:extLst>
                    <a:ext uri="{FF2B5EF4-FFF2-40B4-BE49-F238E27FC236}">
                      <a16:creationId xmlns:a16="http://schemas.microsoft.com/office/drawing/2014/main" id="{3745B31A-72C9-4944-9DC4-384361E72998}"/>
                    </a:ext>
                  </a:extLst>
                </p:cNvPr>
                <p:cNvGrpSpPr/>
                <p:nvPr/>
              </p:nvGrpSpPr>
              <p:grpSpPr>
                <a:xfrm>
                  <a:off x="258894" y="434191"/>
                  <a:ext cx="1790547" cy="186457"/>
                  <a:chOff x="258894" y="434191"/>
                  <a:chExt cx="1790547" cy="186457"/>
                </a:xfrm>
              </p:grpSpPr>
              <p:grpSp>
                <p:nvGrpSpPr>
                  <p:cNvPr id="92" name="Group 91">
                    <a:extLst>
                      <a:ext uri="{FF2B5EF4-FFF2-40B4-BE49-F238E27FC236}">
                        <a16:creationId xmlns:a16="http://schemas.microsoft.com/office/drawing/2014/main" id="{579DDFD6-9CF0-0C4A-A496-EA942305B6F4}"/>
                      </a:ext>
                    </a:extLst>
                  </p:cNvPr>
                  <p:cNvGrpSpPr/>
                  <p:nvPr/>
                </p:nvGrpSpPr>
                <p:grpSpPr>
                  <a:xfrm>
                    <a:off x="258894" y="434191"/>
                    <a:ext cx="1769183" cy="88935"/>
                    <a:chOff x="258836" y="434191"/>
                    <a:chExt cx="8485153" cy="88935"/>
                  </a:xfrm>
                </p:grpSpPr>
                <p:sp>
                  <p:nvSpPr>
                    <p:cNvPr id="97" name="TextBox 20">
                      <a:extLst>
                        <a:ext uri="{FF2B5EF4-FFF2-40B4-BE49-F238E27FC236}">
                          <a16:creationId xmlns:a16="http://schemas.microsoft.com/office/drawing/2014/main" id="{11FBC4EF-3DDF-4E4E-9926-A73461B73D8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836" y="434191"/>
                      <a:ext cx="8485152" cy="8893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solidFill>
                            <a:srgbClr val="385623"/>
                          </a:solidFill>
                          <a:latin typeface="Arial" panose="020B06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Chow Diet</a:t>
                      </a:r>
                      <a:endParaRPr lang="en-AU" sz="1200" dirty="0"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98" name="Straight Arrow Connector 97">
                      <a:extLst>
                        <a:ext uri="{FF2B5EF4-FFF2-40B4-BE49-F238E27FC236}">
                          <a16:creationId xmlns:a16="http://schemas.microsoft.com/office/drawing/2014/main" id="{6CBED0D3-D6C8-1443-BB49-4BD284F1F19E}"/>
                        </a:ext>
                      </a:extLst>
                    </p:cNvPr>
                    <p:cNvCxnSpPr>
                      <a:cxnSpLocks/>
                      <a:endCxn id="97" idx="3"/>
                    </p:cNvCxnSpPr>
                    <p:nvPr/>
                  </p:nvCxnSpPr>
                  <p:spPr>
                    <a:xfrm flipV="1">
                      <a:off x="5222179" y="478659"/>
                      <a:ext cx="3521810" cy="6540"/>
                    </a:xfrm>
                    <a:prstGeom prst="straightConnector1">
                      <a:avLst/>
                    </a:prstGeom>
                    <a:ln w="12700">
                      <a:solidFill>
                        <a:schemeClr val="accent6">
                          <a:lumMod val="50000"/>
                        </a:schemeClr>
                      </a:solidFill>
                      <a:tailEnd type="oval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9" name="Straight Arrow Connector 98">
                      <a:extLst>
                        <a:ext uri="{FF2B5EF4-FFF2-40B4-BE49-F238E27FC236}">
                          <a16:creationId xmlns:a16="http://schemas.microsoft.com/office/drawing/2014/main" id="{A3696540-A7EB-D14A-80BA-9435FA5A5B91}"/>
                        </a:ext>
                      </a:extLst>
                    </p:cNvPr>
                    <p:cNvCxnSpPr>
                      <a:cxnSpLocks/>
                      <a:endCxn id="97" idx="1"/>
                    </p:cNvCxnSpPr>
                    <p:nvPr/>
                  </p:nvCxnSpPr>
                  <p:spPr>
                    <a:xfrm flipH="1" flipV="1">
                      <a:off x="258836" y="478659"/>
                      <a:ext cx="3523646" cy="6540"/>
                    </a:xfrm>
                    <a:prstGeom prst="straightConnector1">
                      <a:avLst/>
                    </a:prstGeom>
                    <a:ln w="12700">
                      <a:solidFill>
                        <a:schemeClr val="accent6">
                          <a:lumMod val="50000"/>
                        </a:schemeClr>
                      </a:solidFill>
                      <a:tailEnd type="oval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93" name="Straight Connector 92">
                    <a:extLst>
                      <a:ext uri="{FF2B5EF4-FFF2-40B4-BE49-F238E27FC236}">
                        <a16:creationId xmlns:a16="http://schemas.microsoft.com/office/drawing/2014/main" id="{66A2E2B3-136B-6A44-A8C7-BE33A85A51C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58910" y="620648"/>
                    <a:ext cx="1536440" cy="0"/>
                  </a:xfrm>
                  <a:prstGeom prst="line">
                    <a:avLst/>
                  </a:prstGeom>
                  <a:ln w="152400">
                    <a:solidFill>
                      <a:schemeClr val="accent6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" name="Straight Connector 93">
                    <a:extLst>
                      <a:ext uri="{FF2B5EF4-FFF2-40B4-BE49-F238E27FC236}">
                        <a16:creationId xmlns:a16="http://schemas.microsoft.com/office/drawing/2014/main" id="{AB99CE05-4E28-A34A-A67E-24697D74D20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1804333" y="620648"/>
                    <a:ext cx="234687" cy="0"/>
                  </a:xfrm>
                  <a:prstGeom prst="line">
                    <a:avLst/>
                  </a:prstGeom>
                  <a:ln w="152400">
                    <a:solidFill>
                      <a:srgbClr val="9452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5" name="Rectangle 94">
                    <a:extLst>
                      <a:ext uri="{FF2B5EF4-FFF2-40B4-BE49-F238E27FC236}">
                        <a16:creationId xmlns:a16="http://schemas.microsoft.com/office/drawing/2014/main" id="{E31CD4B4-36B5-F34A-AD02-7F79B6B553A0}"/>
                      </a:ext>
                    </a:extLst>
                  </p:cNvPr>
                  <p:cNvSpPr/>
                  <p:nvPr/>
                </p:nvSpPr>
                <p:spPr>
                  <a:xfrm>
                    <a:off x="1793683" y="508804"/>
                    <a:ext cx="255758" cy="833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9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rPr>
                      <a:t>10 days</a:t>
                    </a:r>
                    <a:endParaRPr lang="en-AU" sz="1600" dirty="0">
                      <a:latin typeface="Arial" panose="020B0604020202020204" pitchFamily="34" charset="0"/>
                      <a:ea typeface="DengXian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6" name="Rectangle 95">
                    <a:extLst>
                      <a:ext uri="{FF2B5EF4-FFF2-40B4-BE49-F238E27FC236}">
                        <a16:creationId xmlns:a16="http://schemas.microsoft.com/office/drawing/2014/main" id="{AC317E11-87EF-0B40-9871-06E0FA967307}"/>
                      </a:ext>
                    </a:extLst>
                  </p:cNvPr>
                  <p:cNvSpPr/>
                  <p:nvPr/>
                </p:nvSpPr>
                <p:spPr>
                  <a:xfrm>
                    <a:off x="264104" y="508804"/>
                    <a:ext cx="1763973" cy="833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9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rPr>
                      <a:t>18 weeks</a:t>
                    </a:r>
                    <a:endParaRPr lang="en-AU" sz="1600" dirty="0">
                      <a:latin typeface="Arial" panose="020B0604020202020204" pitchFamily="34" charset="0"/>
                      <a:ea typeface="DengXian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1" name="TextBox 14">
                  <a:extLst>
                    <a:ext uri="{FF2B5EF4-FFF2-40B4-BE49-F238E27FC236}">
                      <a16:creationId xmlns:a16="http://schemas.microsoft.com/office/drawing/2014/main" id="{E517E002-7254-4D4D-96FD-3725C31E1984}"/>
                    </a:ext>
                  </a:extLst>
                </p:cNvPr>
                <p:cNvSpPr txBox="1"/>
                <p:nvPr/>
              </p:nvSpPr>
              <p:spPr>
                <a:xfrm>
                  <a:off x="54711" y="180461"/>
                  <a:ext cx="210829" cy="889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DengXian" panose="02010600030101010101" pitchFamily="2" charset="-122"/>
                      <a:cs typeface="Arial" panose="020B0604020202020204" pitchFamily="34" charset="0"/>
                    </a:rPr>
                    <a:t>FaD</a:t>
                  </a:r>
                  <a:endParaRPr lang="en-AU" sz="1200" dirty="0"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2" name="TextBox 5">
                <a:extLst>
                  <a:ext uri="{FF2B5EF4-FFF2-40B4-BE49-F238E27FC236}">
                    <a16:creationId xmlns:a16="http://schemas.microsoft.com/office/drawing/2014/main" id="{CA99173D-7C98-5E4F-956B-C7D3C7227B8A}"/>
                  </a:ext>
                </a:extLst>
              </p:cNvPr>
              <p:cNvSpPr txBox="1"/>
              <p:nvPr/>
            </p:nvSpPr>
            <p:spPr>
              <a:xfrm>
                <a:off x="51396" y="1"/>
                <a:ext cx="486410" cy="2564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A</a:t>
                </a:r>
                <a:endParaRPr lang="en-AU" sz="12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6">
                <a:extLst>
                  <a:ext uri="{FF2B5EF4-FFF2-40B4-BE49-F238E27FC236}">
                    <a16:creationId xmlns:a16="http://schemas.microsoft.com/office/drawing/2014/main" id="{FCE393BB-95C5-B84A-99D8-EEE3F4E1D908}"/>
                  </a:ext>
                </a:extLst>
              </p:cNvPr>
              <p:cNvSpPr txBox="1"/>
              <p:nvPr/>
            </p:nvSpPr>
            <p:spPr>
              <a:xfrm>
                <a:off x="45438" y="911807"/>
                <a:ext cx="485775" cy="2564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B</a:t>
                </a:r>
                <a:endParaRPr lang="en-AU" sz="12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7">
                <a:extLst>
                  <a:ext uri="{FF2B5EF4-FFF2-40B4-BE49-F238E27FC236}">
                    <a16:creationId xmlns:a16="http://schemas.microsoft.com/office/drawing/2014/main" id="{162FC84D-567B-B94B-B03E-EDBA85FB8EA6}"/>
                  </a:ext>
                </a:extLst>
              </p:cNvPr>
              <p:cNvSpPr txBox="1"/>
              <p:nvPr/>
            </p:nvSpPr>
            <p:spPr>
              <a:xfrm>
                <a:off x="0" y="1232576"/>
                <a:ext cx="595631" cy="205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>
                    <a:solidFill>
                      <a:srgbClr val="000000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Chow</a:t>
                </a:r>
                <a:endParaRPr lang="en-AU" sz="120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85" name="Graphic 8" descr="Adhesive Bandage with solid fill">
                <a:extLst>
                  <a:ext uri="{FF2B5EF4-FFF2-40B4-BE49-F238E27FC236}">
                    <a16:creationId xmlns:a16="http://schemas.microsoft.com/office/drawing/2014/main" id="{E813B6E5-3129-7C43-AC56-A78AF3AE14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3989900" y="1283593"/>
                <a:ext cx="170592" cy="170592"/>
              </a:xfrm>
              <a:prstGeom prst="rect">
                <a:avLst/>
              </a:prstGeom>
            </p:spPr>
          </p:pic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0C56C7B2-B084-AB4D-AE7F-7B50FE44FE6D}"/>
                  </a:ext>
                </a:extLst>
              </p:cNvPr>
              <p:cNvSpPr/>
              <p:nvPr/>
            </p:nvSpPr>
            <p:spPr>
              <a:xfrm>
                <a:off x="3915015" y="1396488"/>
                <a:ext cx="351790" cy="2308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200">
                    <a:solidFill>
                      <a:srgbClr val="000000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Ⓒ</a:t>
                </a:r>
                <a:endParaRPr lang="en-AU" sz="120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659ACDEB-3EBA-884E-A08C-107B50B58A2B}"/>
                  </a:ext>
                </a:extLst>
              </p:cNvPr>
              <p:cNvSpPr/>
              <p:nvPr/>
            </p:nvSpPr>
            <p:spPr>
              <a:xfrm>
                <a:off x="4434767" y="1397448"/>
                <a:ext cx="351790" cy="2308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Ⓓ</a:t>
                </a:r>
                <a:endParaRPr lang="en-AU" sz="12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88" name="Graphic 11" descr="Camera with solid fill">
                <a:extLst>
                  <a:ext uri="{FF2B5EF4-FFF2-40B4-BE49-F238E27FC236}">
                    <a16:creationId xmlns:a16="http://schemas.microsoft.com/office/drawing/2014/main" id="{03EB77FE-56C6-B146-B4CF-0F3DB4A3F35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8"/>
                  </a:ext>
                </a:extLst>
              </a:blip>
              <a:stretch>
                <a:fillRect/>
              </a:stretch>
            </p:blipFill>
            <p:spPr>
              <a:xfrm>
                <a:off x="4263736" y="1436401"/>
                <a:ext cx="197382" cy="197382"/>
              </a:xfrm>
              <a:prstGeom prst="rect">
                <a:avLst/>
              </a:prstGeom>
            </p:spPr>
          </p:pic>
        </p:grpSp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016EA59D-F453-B34E-AABE-A71783B425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ackgroundRemoval t="6369" b="97452" l="1765" r="99412">
                          <a14:foregroundMark x1="3529" y1="76433" x2="3529" y2="76433"/>
                          <a14:foregroundMark x1="25294" y1="97452" x2="25294" y2="97452"/>
                          <a14:foregroundMark x1="50588" y1="6369" x2="50588" y2="6369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49227" y="3783060"/>
              <a:ext cx="1134130" cy="1043774"/>
            </a:xfrm>
            <a:prstGeom prst="rect">
              <a:avLst/>
            </a:prstGeom>
          </p:spPr>
        </p:pic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5E8BBAB3-0F65-DA43-9577-D9C177F868C9}"/>
                </a:ext>
              </a:extLst>
            </p:cNvPr>
            <p:cNvSpPr/>
            <p:nvPr/>
          </p:nvSpPr>
          <p:spPr>
            <a:xfrm>
              <a:off x="1274677" y="3600690"/>
              <a:ext cx="1125182" cy="20518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000" dirty="0">
                  <a:solidFill>
                    <a:srgbClr val="000000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Wounding</a:t>
              </a:r>
              <a:endParaRPr lang="en-AU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7306772C-6676-A94D-B317-2FABB8CFA92B}"/>
                </a:ext>
              </a:extLst>
            </p:cNvPr>
            <p:cNvSpPr/>
            <p:nvPr/>
          </p:nvSpPr>
          <p:spPr>
            <a:xfrm>
              <a:off x="3547901" y="3575099"/>
              <a:ext cx="1134132" cy="20518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000" dirty="0">
                  <a:solidFill>
                    <a:srgbClr val="000000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Termination</a:t>
              </a:r>
              <a:endParaRPr lang="en-AU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F43DE25D-E39E-A149-8647-D4CF99ECBC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6369" b="97452" l="1765" r="99412">
                          <a14:foregroundMark x1="3529" y1="76433" x2="3529" y2="76433"/>
                          <a14:foregroundMark x1="25294" y1="97452" x2="25294" y2="97452"/>
                          <a14:foregroundMark x1="50588" y1="6369" x2="50588" y2="6369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47254" y="3784974"/>
              <a:ext cx="1134130" cy="1043774"/>
            </a:xfrm>
            <a:prstGeom prst="rect">
              <a:avLst/>
            </a:prstGeom>
          </p:spPr>
        </p:pic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8366B9C3-3319-F54F-8A04-7E8F021067B8}"/>
                </a:ext>
              </a:extLst>
            </p:cNvPr>
            <p:cNvSpPr/>
            <p:nvPr/>
          </p:nvSpPr>
          <p:spPr>
            <a:xfrm>
              <a:off x="3799049" y="4078430"/>
              <a:ext cx="656329" cy="654981"/>
            </a:xfrm>
            <a:prstGeom prst="rect">
              <a:avLst/>
            </a:prstGeom>
            <a:noFill/>
            <a:ln w="6350">
              <a:solidFill>
                <a:srgbClr val="FF0000"/>
              </a:solidFill>
              <a:prstDash val="sysDash"/>
              <a:extLst>
                <a:ext uri="{C807C97D-BFC1-408E-A445-0C87EB9F89A2}">
                  <ask:lineSketchStyleProps xmlns:ask="http://schemas.microsoft.com/office/drawing/2018/sketchyshapes" sd="1219033472">
                    <a:custGeom>
                      <a:avLst/>
                      <a:gdLst>
                        <a:gd name="connsiteX0" fmla="*/ 0 w 1053680"/>
                        <a:gd name="connsiteY0" fmla="*/ 0 h 1053680"/>
                        <a:gd name="connsiteX1" fmla="*/ 1053680 w 1053680"/>
                        <a:gd name="connsiteY1" fmla="*/ 0 h 1053680"/>
                        <a:gd name="connsiteX2" fmla="*/ 1053680 w 1053680"/>
                        <a:gd name="connsiteY2" fmla="*/ 1053680 h 1053680"/>
                        <a:gd name="connsiteX3" fmla="*/ 0 w 1053680"/>
                        <a:gd name="connsiteY3" fmla="*/ 1053680 h 1053680"/>
                        <a:gd name="connsiteX4" fmla="*/ 0 w 1053680"/>
                        <a:gd name="connsiteY4" fmla="*/ 0 h 105368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1053680" h="1053680" extrusionOk="0">
                          <a:moveTo>
                            <a:pt x="0" y="0"/>
                          </a:moveTo>
                          <a:cubicBezTo>
                            <a:pt x="471136" y="54547"/>
                            <a:pt x="868743" y="51584"/>
                            <a:pt x="1053680" y="0"/>
                          </a:cubicBezTo>
                          <a:cubicBezTo>
                            <a:pt x="1139205" y="319204"/>
                            <a:pt x="1090755" y="724421"/>
                            <a:pt x="1053680" y="1053680"/>
                          </a:cubicBezTo>
                          <a:cubicBezTo>
                            <a:pt x="531496" y="1008679"/>
                            <a:pt x="109961" y="1047355"/>
                            <a:pt x="0" y="1053680"/>
                          </a:cubicBezTo>
                          <a:cubicBezTo>
                            <a:pt x="-26113" y="802349"/>
                            <a:pt x="-49335" y="434603"/>
                            <a:pt x="0" y="0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4A4801A3-5FC4-F74F-98C4-FDA6538F85C9}"/>
                </a:ext>
              </a:extLst>
            </p:cNvPr>
            <p:cNvGrpSpPr/>
            <p:nvPr/>
          </p:nvGrpSpPr>
          <p:grpSpPr>
            <a:xfrm>
              <a:off x="3875468" y="4155053"/>
              <a:ext cx="506079" cy="504620"/>
              <a:chOff x="376731" y="2984435"/>
              <a:chExt cx="262708" cy="261944"/>
            </a:xfrm>
          </p:grpSpPr>
          <p:sp>
            <p:nvSpPr>
              <p:cNvPr id="73" name="Oval 72">
                <a:extLst>
                  <a:ext uri="{FF2B5EF4-FFF2-40B4-BE49-F238E27FC236}">
                    <a16:creationId xmlns:a16="http://schemas.microsoft.com/office/drawing/2014/main" id="{AEF4D25F-DD56-1244-A235-FCD67BD98D0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76731" y="2984435"/>
                <a:ext cx="93439" cy="93439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Oval 73">
                <a:extLst>
                  <a:ext uri="{FF2B5EF4-FFF2-40B4-BE49-F238E27FC236}">
                    <a16:creationId xmlns:a16="http://schemas.microsoft.com/office/drawing/2014/main" id="{EAFAE5B6-338B-804E-9B7D-ADC4E864B2C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000" y="2984436"/>
                <a:ext cx="93439" cy="93439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Oval 74">
                <a:extLst>
                  <a:ext uri="{FF2B5EF4-FFF2-40B4-BE49-F238E27FC236}">
                    <a16:creationId xmlns:a16="http://schemas.microsoft.com/office/drawing/2014/main" id="{27B1DA0E-B4BD-C243-AB94-D753E0361AE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76731" y="3152940"/>
                <a:ext cx="93439" cy="93439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Oval 75">
                <a:extLst>
                  <a:ext uri="{FF2B5EF4-FFF2-40B4-BE49-F238E27FC236}">
                    <a16:creationId xmlns:a16="http://schemas.microsoft.com/office/drawing/2014/main" id="{C03ACAA2-7A17-E443-B83A-45052EF2510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003" y="3149544"/>
                <a:ext cx="93436" cy="93437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6748AAA7-881F-DB49-BC71-7FD6BA9D8548}"/>
                </a:ext>
              </a:extLst>
            </p:cNvPr>
            <p:cNvCxnSpPr>
              <a:cxnSpLocks/>
            </p:cNvCxnSpPr>
            <p:nvPr/>
          </p:nvCxnSpPr>
          <p:spPr>
            <a:xfrm>
              <a:off x="3804033" y="4404028"/>
              <a:ext cx="651344" cy="1892"/>
            </a:xfrm>
            <a:prstGeom prst="line">
              <a:avLst/>
            </a:prstGeom>
            <a:ln w="6350">
              <a:solidFill>
                <a:srgbClr val="FF0000"/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27F33F64-06FD-A74B-B1EE-FEB48F345969}"/>
                </a:ext>
              </a:extLst>
            </p:cNvPr>
            <p:cNvCxnSpPr>
              <a:cxnSpLocks/>
            </p:cNvCxnSpPr>
            <p:nvPr/>
          </p:nvCxnSpPr>
          <p:spPr>
            <a:xfrm>
              <a:off x="4125128" y="4078365"/>
              <a:ext cx="0" cy="658844"/>
            </a:xfrm>
            <a:prstGeom prst="line">
              <a:avLst/>
            </a:prstGeom>
            <a:ln w="6350">
              <a:solidFill>
                <a:srgbClr val="FF0000"/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6673C4B5-69BF-BB43-80D7-127C1E640719}"/>
                </a:ext>
              </a:extLst>
            </p:cNvPr>
            <p:cNvGrpSpPr/>
            <p:nvPr/>
          </p:nvGrpSpPr>
          <p:grpSpPr>
            <a:xfrm>
              <a:off x="1557475" y="4124469"/>
              <a:ext cx="506079" cy="504620"/>
              <a:chOff x="376731" y="2984435"/>
              <a:chExt cx="262708" cy="261944"/>
            </a:xfrm>
          </p:grpSpPr>
          <p:sp>
            <p:nvSpPr>
              <p:cNvPr id="119" name="Oval 118">
                <a:extLst>
                  <a:ext uri="{FF2B5EF4-FFF2-40B4-BE49-F238E27FC236}">
                    <a16:creationId xmlns:a16="http://schemas.microsoft.com/office/drawing/2014/main" id="{20C37878-8FE4-6246-9687-10A62D9D32B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76731" y="2984435"/>
                <a:ext cx="93439" cy="93439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Oval 119">
                <a:extLst>
                  <a:ext uri="{FF2B5EF4-FFF2-40B4-BE49-F238E27FC236}">
                    <a16:creationId xmlns:a16="http://schemas.microsoft.com/office/drawing/2014/main" id="{59E30126-5288-F147-A821-C0D56AD06A1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000" y="2984436"/>
                <a:ext cx="93439" cy="93439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Oval 120">
                <a:extLst>
                  <a:ext uri="{FF2B5EF4-FFF2-40B4-BE49-F238E27FC236}">
                    <a16:creationId xmlns:a16="http://schemas.microsoft.com/office/drawing/2014/main" id="{AA9E0EE0-3CB5-124D-BC5C-CB51D9360F9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76731" y="3152940"/>
                <a:ext cx="93439" cy="93439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Oval 121">
                <a:extLst>
                  <a:ext uri="{FF2B5EF4-FFF2-40B4-BE49-F238E27FC236}">
                    <a16:creationId xmlns:a16="http://schemas.microsoft.com/office/drawing/2014/main" id="{40A80626-BE0F-EF41-8F86-D85CDF24627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003" y="3149544"/>
                <a:ext cx="93436" cy="93437"/>
              </a:xfrm>
              <a:prstGeom prst="ellipse">
                <a:avLst/>
              </a:prstGeom>
              <a:solidFill>
                <a:schemeClr val="bg2"/>
              </a:solidFill>
              <a:ln w="6350">
                <a:noFill/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DAC1E73E-FE1B-FE4E-B83F-C2E09FFEEB38}"/>
                </a:ext>
              </a:extLst>
            </p:cNvPr>
            <p:cNvCxnSpPr>
              <a:cxnSpLocks/>
            </p:cNvCxnSpPr>
            <p:nvPr/>
          </p:nvCxnSpPr>
          <p:spPr>
            <a:xfrm>
              <a:off x="1557475" y="4217406"/>
              <a:ext cx="180000" cy="0"/>
            </a:xfrm>
            <a:prstGeom prst="line">
              <a:avLst/>
            </a:prstGeom>
            <a:ln w="6350">
              <a:solidFill>
                <a:schemeClr val="tx1">
                  <a:lumMod val="75000"/>
                  <a:lumOff val="25000"/>
                </a:schemeClr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46EEFAAB-55A5-FB48-8796-B74DB4B4CEBC}"/>
                </a:ext>
              </a:extLst>
            </p:cNvPr>
            <p:cNvSpPr/>
            <p:nvPr/>
          </p:nvSpPr>
          <p:spPr>
            <a:xfrm>
              <a:off x="1458699" y="4104696"/>
              <a:ext cx="374256" cy="1410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500" dirty="0">
                  <a:solidFill>
                    <a:srgbClr val="000000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4mm</a:t>
              </a:r>
              <a:endParaRPr lang="en-AU" sz="5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02726D19-391C-EE47-B869-13A3CDA3F08A}"/>
                </a:ext>
              </a:extLst>
            </p:cNvPr>
            <p:cNvSpPr/>
            <p:nvPr/>
          </p:nvSpPr>
          <p:spPr>
            <a:xfrm>
              <a:off x="3752571" y="3921225"/>
              <a:ext cx="427035" cy="16671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700" dirty="0">
                  <a:solidFill>
                    <a:srgbClr val="FFFFFF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8mm</a:t>
              </a:r>
              <a:endParaRPr lang="en-AU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7" name="TextBox 43">
              <a:extLst>
                <a:ext uri="{FF2B5EF4-FFF2-40B4-BE49-F238E27FC236}">
                  <a16:creationId xmlns:a16="http://schemas.microsoft.com/office/drawing/2014/main" id="{E292222D-89C3-D443-987B-57D5952868D9}"/>
                </a:ext>
              </a:extLst>
            </p:cNvPr>
            <p:cNvSpPr txBox="1"/>
            <p:nvPr/>
          </p:nvSpPr>
          <p:spPr>
            <a:xfrm>
              <a:off x="1158825" y="3514298"/>
              <a:ext cx="310505" cy="256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000000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C</a:t>
              </a:r>
              <a:endParaRPr lang="en-AU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8" name="TextBox 44">
              <a:extLst>
                <a:ext uri="{FF2B5EF4-FFF2-40B4-BE49-F238E27FC236}">
                  <a16:creationId xmlns:a16="http://schemas.microsoft.com/office/drawing/2014/main" id="{55FC6318-1490-884C-9603-FB317CAE01AF}"/>
                </a:ext>
              </a:extLst>
            </p:cNvPr>
            <p:cNvSpPr txBox="1"/>
            <p:nvPr/>
          </p:nvSpPr>
          <p:spPr>
            <a:xfrm>
              <a:off x="3429998" y="3513522"/>
              <a:ext cx="310505" cy="256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000000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D</a:t>
              </a:r>
              <a:endParaRPr lang="en-AU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59" name="Picture 58" descr="A picture containing indoor, rodent&#10;&#10;Description automatically generated">
              <a:extLst>
                <a:ext uri="{FF2B5EF4-FFF2-40B4-BE49-F238E27FC236}">
                  <a16:creationId xmlns:a16="http://schemas.microsoft.com/office/drawing/2014/main" id="{5E02A0C2-4802-E241-A248-F7096803C0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400000">
              <a:off x="2412503" y="3847776"/>
              <a:ext cx="1004851" cy="946848"/>
            </a:xfrm>
            <a:prstGeom prst="rect">
              <a:avLst/>
            </a:prstGeom>
          </p:spPr>
        </p:pic>
        <p:pic>
          <p:nvPicPr>
            <p:cNvPr id="60" name="Picture 59" descr="A picture containing indoor, black, laying, mammal&#10;&#10;Description automatically generated">
              <a:extLst>
                <a:ext uri="{FF2B5EF4-FFF2-40B4-BE49-F238E27FC236}">
                  <a16:creationId xmlns:a16="http://schemas.microsoft.com/office/drawing/2014/main" id="{39A3E040-5798-9643-87EE-FD8845403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400000">
              <a:off x="4690227" y="3850989"/>
              <a:ext cx="1004851" cy="946848"/>
            </a:xfrm>
            <a:prstGeom prst="rect">
              <a:avLst/>
            </a:prstGeom>
          </p:spPr>
        </p:pic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1ED607D7-F8C6-7045-8C3E-9FF32E7F8EE7}"/>
                </a:ext>
              </a:extLst>
            </p:cNvPr>
            <p:cNvCxnSpPr/>
            <p:nvPr/>
          </p:nvCxnSpPr>
          <p:spPr bwMode="auto">
            <a:xfrm>
              <a:off x="4689553" y="4715872"/>
              <a:ext cx="0" cy="174624"/>
            </a:xfrm>
            <a:prstGeom prst="straightConnector1">
              <a:avLst/>
            </a:prstGeom>
            <a:gradFill rotWithShape="1">
              <a:gsLst>
                <a:gs pos="0">
                  <a:srgbClr val="800000"/>
                </a:gs>
                <a:gs pos="50000">
                  <a:srgbClr val="800000">
                    <a:gamma/>
                    <a:tint val="73725"/>
                    <a:invGamma/>
                  </a:srgbClr>
                </a:gs>
                <a:gs pos="100000">
                  <a:srgbClr val="800000"/>
                </a:gs>
              </a:gsLst>
              <a:lin ang="5400000" scaled="1"/>
            </a:gradFill>
            <a:ln w="6350" cap="flat" cmpd="sng" algn="ctr">
              <a:solidFill>
                <a:schemeClr val="bg1">
                  <a:alpha val="62000"/>
                </a:schemeClr>
              </a:solidFill>
              <a:prstDash val="solid"/>
              <a:round/>
              <a:headEnd type="none" w="med" len="med"/>
              <a:tailEnd type="none" w="sm" len="sm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1604255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82b3e37e-8171-485d-b10b-38dae7ed14a8}" enabled="0" method="" siteId="{82b3e37e-8171-485d-b10b-38dae7ed14a8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53</TotalTime>
  <Words>31</Words>
  <Application>Microsoft Macintosh PowerPoint</Application>
  <PresentationFormat>Custom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nuscript 1</dc:title>
  <dc:creator>Coco Huang</dc:creator>
  <cp:lastModifiedBy>Coco Huang</cp:lastModifiedBy>
  <cp:revision>150</cp:revision>
  <dcterms:created xsi:type="dcterms:W3CDTF">2021-12-06T02:44:08Z</dcterms:created>
  <dcterms:modified xsi:type="dcterms:W3CDTF">2023-08-29T02:01:58Z</dcterms:modified>
</cp:coreProperties>
</file>